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2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70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E3EECD-EE98-4BBE-9F01-67E2BA78C2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BA7A567-21DC-4ABB-84C9-7F03A03A10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662A722-9377-4884-A40C-AE05B27B9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0CB0E-CF2C-4E1E-AA5D-520D552B3584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389A964-BBE5-4049-B5E9-3E2B604CB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A5E16B6-7573-49C7-B4BC-66ED57607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D6C16-5AD4-4DBD-A2C1-DB73F39EBC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0199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37C036-68A4-4EE5-A104-A0122F9EBC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18E5865-CD04-46F4-AFCD-404AFC5EBD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E934A30-E8C8-44C6-BB0F-CB3A67EC8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0CB0E-CF2C-4E1E-AA5D-520D552B3584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F237EBD-45C7-4F50-BD18-38078A4953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BB661EE-5F21-4EF8-8BF2-8A5E9D7F8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D6C16-5AD4-4DBD-A2C1-DB73F39EBC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7835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D66475A-6EE8-4CEA-B984-775AC82D55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80FA05A-CEC5-43E0-A06C-3FFDAEFE57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D8DEAA8-2575-45A7-8A7A-CF28C7754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0CB0E-CF2C-4E1E-AA5D-520D552B3584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E2E6E2-8ED9-4CBF-8477-725A67388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F81B020-CF77-4FAF-8E34-7525CD59B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D6C16-5AD4-4DBD-A2C1-DB73F39EBC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8129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1F82C4-4F85-4494-BCE8-8EA83C3B45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3575FD2-D6AB-45F7-AB3B-1E01B1D053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AA8BA45-E866-48FD-998F-3DD26AB2D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0CB0E-CF2C-4E1E-AA5D-520D552B3584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3291FDF-ABA5-4E3C-9EE9-4E2A6071D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D2336C-440D-4994-8009-777CDE7AF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D6C16-5AD4-4DBD-A2C1-DB73F39EBC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179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19C786-677B-4FA9-B0F2-4362C6DAA9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C966D6F-1356-440C-99ED-E02031C5F3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EC56517-DCB2-4662-B2E6-B1314B46F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0CB0E-CF2C-4E1E-AA5D-520D552B3584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C81F39-C22C-4B71-9A09-DA5114AA69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709D20-978F-4FA6-8ED8-29FC97234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D6C16-5AD4-4DBD-A2C1-DB73F39EBC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4440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797F02-EB88-4342-AE85-F9E5626F55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875696-5C08-4AD3-9F69-F5C127D653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DECF8F5-1375-442A-B328-6801B46430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CF88CD5-5B0F-40BC-BEBE-D6C6A6C88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0CB0E-CF2C-4E1E-AA5D-520D552B3584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CABF9C1-0E7A-4C23-B76D-0B7F34D11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6D4FF8F-24D0-4D36-A2D0-6FADDD78EB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D6C16-5AD4-4DBD-A2C1-DB73F39EBC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5702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96F879-EF97-4ABF-B409-C458F47BFE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0CE9A10-8454-4D55-A9BD-216CFB0EA6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F31DFF6-E619-4172-9248-5C105F6948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F0DAC6A-C922-4EAF-84CB-C6E771F0A0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2487D3C-F94C-4A68-BBBF-11EB046004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9638154-6936-4BE9-A0BE-FBB0F9F43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0CB0E-CF2C-4E1E-AA5D-520D552B3584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1BEA0A3-5660-4B04-A94E-644B546321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4EB0CB6-644C-4217-A0C8-484309940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D6C16-5AD4-4DBD-A2C1-DB73F39EBC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7664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887CA6-3D33-4A6A-A324-C9B5268E2C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B0906AF-8D7E-4CB8-A326-70A340A0A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0CB0E-CF2C-4E1E-AA5D-520D552B3584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950DD8E-CA95-4F94-BBE4-EB0B56244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F447438-3131-4858-AC07-A7561F775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D6C16-5AD4-4DBD-A2C1-DB73F39EBC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2223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AB3B38F-224D-49F8-B7E3-0ABD34E01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0CB0E-CF2C-4E1E-AA5D-520D552B3584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8C0C830-F75E-49F0-874E-7E2517297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AA5C6FE-9EC6-4E84-BAF6-FC18A801D3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D6C16-5AD4-4DBD-A2C1-DB73F39EBC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1672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C4EE60-26BF-4E27-BF07-0D3437CDD6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674ED95-95B2-4AE8-9B12-5289106CE4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F3CDD77-46D7-4788-8F30-C952C3B963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8F350F3-8188-41CC-B883-0DB7F387AE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0CB0E-CF2C-4E1E-AA5D-520D552B3584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768003C-5733-458D-8321-7288723206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5EE6F1C-682F-495D-A9E0-EDB17279A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D6C16-5AD4-4DBD-A2C1-DB73F39EBC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1364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6A918E-970C-4EE4-BFA3-C97ED8605A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1DA66BB-17B6-4BF0-97B0-63AB889901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A790A93-766E-4951-B93F-2D5ECE14A5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EFDDF00-61FB-4C38-A8DD-08BA0665F7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E0CB0E-CF2C-4E1E-AA5D-520D552B3584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70FA39-FBFE-40DD-A6BD-E31D607F50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18AF6E6-F96D-4E17-8C64-114601CC52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DD6C16-5AD4-4DBD-A2C1-DB73F39EBC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791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14170C5-D49A-467B-86BD-B9937CE278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C9EF903-D8AB-4D80-9ED5-A39A7CAEE1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C8E8002-505E-4A24-8E4A-4861283D8A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E0CB0E-CF2C-4E1E-AA5D-520D552B3584}" type="datetimeFigureOut">
              <a:rPr kumimoji="1" lang="ja-JP" altLang="en-US" smtClean="0"/>
              <a:t>2021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FFD607F-E8F8-43D9-9C56-633800B117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DA69EA9-E6AC-444E-AF08-63E8FE8D1B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DD6C16-5AD4-4DBD-A2C1-DB73F39EBC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3086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図 30">
            <a:extLst>
              <a:ext uri="{FF2B5EF4-FFF2-40B4-BE49-F238E27FC236}">
                <a16:creationId xmlns:a16="http://schemas.microsoft.com/office/drawing/2014/main" id="{7A25DCF4-C715-4F79-ABB0-BA61F57663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76346" y="1301173"/>
            <a:ext cx="3475021" cy="2331922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50AF4E68-3D73-4D7E-86CA-DB14E8A3B5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5629" y="1301173"/>
            <a:ext cx="3475021" cy="2331922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B09B346-250F-4F15-917B-38AE464FD2CB}"/>
              </a:ext>
            </a:extLst>
          </p:cNvPr>
          <p:cNvSpPr txBox="1"/>
          <p:nvPr/>
        </p:nvSpPr>
        <p:spPr>
          <a:xfrm>
            <a:off x="688111" y="258094"/>
            <a:ext cx="10058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Suppl. Fig.</a:t>
            </a:r>
            <a:r>
              <a:rPr lang="ja-JP" altLang="en-US" dirty="0"/>
              <a:t> </a:t>
            </a:r>
            <a:r>
              <a:rPr lang="en-US" altLang="ja-JP" dirty="0"/>
              <a:t>1</a:t>
            </a:r>
            <a:r>
              <a:rPr lang="ja-JP" altLang="en-US" dirty="0"/>
              <a:t>　</a:t>
            </a:r>
            <a:r>
              <a:rPr lang="en-US" altLang="ja-JP" dirty="0"/>
              <a:t>Biochemical</a:t>
            </a:r>
            <a:r>
              <a:rPr lang="ja-JP" altLang="en-US" dirty="0"/>
              <a:t> </a:t>
            </a:r>
            <a:r>
              <a:rPr lang="en-US" altLang="ja-JP" dirty="0"/>
              <a:t>recurrence-free</a:t>
            </a:r>
            <a:r>
              <a:rPr lang="ja-JP" altLang="en-US" dirty="0"/>
              <a:t> </a:t>
            </a:r>
            <a:r>
              <a:rPr lang="en-US" altLang="ja-JP" dirty="0"/>
              <a:t>survival</a:t>
            </a:r>
            <a:r>
              <a:rPr lang="ja-JP" altLang="en-US" dirty="0"/>
              <a:t> </a:t>
            </a:r>
            <a:r>
              <a:rPr lang="en-US" altLang="ja-JP" dirty="0"/>
              <a:t>of</a:t>
            </a:r>
            <a:r>
              <a:rPr lang="ja-JP" altLang="en-US" dirty="0"/>
              <a:t> </a:t>
            </a:r>
            <a:r>
              <a:rPr lang="en-US" altLang="ja-JP" dirty="0"/>
              <a:t>patients (pre-operative ISUP</a:t>
            </a:r>
            <a:r>
              <a:rPr lang="ja-JP" altLang="en-US" dirty="0"/>
              <a:t> </a:t>
            </a:r>
            <a:r>
              <a:rPr lang="en-US" altLang="ja-JP" dirty="0"/>
              <a:t>grade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</a:t>
            </a:r>
            <a:r>
              <a:rPr lang="en-US" altLang="ja-JP" dirty="0"/>
              <a:t>2)</a:t>
            </a:r>
          </a:p>
          <a:p>
            <a:r>
              <a:rPr lang="en-US" altLang="ja-JP" dirty="0"/>
              <a:t>                       stratified by surgical margin</a:t>
            </a:r>
          </a:p>
          <a:p>
            <a:r>
              <a:rPr lang="en-US" altLang="ja-JP" dirty="0"/>
              <a:t>               </a:t>
            </a:r>
          </a:p>
          <a:p>
            <a:endParaRPr lang="ja-JP" altLang="en-US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09B9633-CF92-40BB-B061-CF2C7ECEC089}"/>
              </a:ext>
            </a:extLst>
          </p:cNvPr>
          <p:cNvSpPr txBox="1"/>
          <p:nvPr/>
        </p:nvSpPr>
        <p:spPr>
          <a:xfrm flipH="1">
            <a:off x="829625" y="904425"/>
            <a:ext cx="337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A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1867534-F2E6-4768-B56E-9B9ABB7C1EAC}"/>
              </a:ext>
            </a:extLst>
          </p:cNvPr>
          <p:cNvSpPr txBox="1"/>
          <p:nvPr/>
        </p:nvSpPr>
        <p:spPr>
          <a:xfrm>
            <a:off x="1156014" y="944250"/>
            <a:ext cx="34712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Surgical margin :</a:t>
            </a:r>
            <a:r>
              <a:rPr lang="ja-JP" altLang="en-US" sz="1400" dirty="0"/>
              <a:t> </a:t>
            </a:r>
            <a:r>
              <a:rPr lang="en-US" altLang="ja-JP" sz="1400" dirty="0"/>
              <a:t>negative</a:t>
            </a:r>
            <a:r>
              <a:rPr lang="ja-JP" altLang="en-US" sz="1400" dirty="0"/>
              <a:t> </a:t>
            </a:r>
            <a:r>
              <a:rPr lang="en-US" altLang="ja-JP" sz="1400" dirty="0"/>
              <a:t>(N=359)</a:t>
            </a:r>
            <a:endParaRPr lang="ja-JP" altLang="en-US" sz="14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DDD045C-9C98-4936-B29E-8C56D7C53E75}"/>
              </a:ext>
            </a:extLst>
          </p:cNvPr>
          <p:cNvSpPr txBox="1"/>
          <p:nvPr/>
        </p:nvSpPr>
        <p:spPr>
          <a:xfrm>
            <a:off x="4533689" y="910455"/>
            <a:ext cx="435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B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CA1939A-D118-4F94-83C8-8DC3EC3CC471}"/>
              </a:ext>
            </a:extLst>
          </p:cNvPr>
          <p:cNvSpPr txBox="1"/>
          <p:nvPr/>
        </p:nvSpPr>
        <p:spPr>
          <a:xfrm>
            <a:off x="4826167" y="935821"/>
            <a:ext cx="35329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Surgical margin :</a:t>
            </a:r>
            <a:r>
              <a:rPr lang="ja-JP" altLang="en-US" sz="1400" dirty="0"/>
              <a:t> </a:t>
            </a:r>
            <a:r>
              <a:rPr lang="en-US" altLang="ja-JP" sz="1400" dirty="0"/>
              <a:t>positive (N=118)</a:t>
            </a:r>
            <a:endParaRPr lang="ja-JP" altLang="en-US" sz="14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07C760D-FEA3-4949-88E4-74C4A4906C42}"/>
              </a:ext>
            </a:extLst>
          </p:cNvPr>
          <p:cNvSpPr txBox="1"/>
          <p:nvPr/>
        </p:nvSpPr>
        <p:spPr>
          <a:xfrm>
            <a:off x="1183311" y="2967370"/>
            <a:ext cx="1904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P value: 0.0137</a:t>
            </a:r>
            <a:endParaRPr lang="ja-JP" altLang="en-US" sz="14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BB71022-941A-419D-B3E5-8DF18369A374}"/>
              </a:ext>
            </a:extLst>
          </p:cNvPr>
          <p:cNvSpPr txBox="1"/>
          <p:nvPr/>
        </p:nvSpPr>
        <p:spPr>
          <a:xfrm>
            <a:off x="4845447" y="2971058"/>
            <a:ext cx="1904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P value: 0.6061</a:t>
            </a:r>
            <a:endParaRPr lang="ja-JP" altLang="en-US" sz="1400" dirty="0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97E1588B-B483-401A-920A-678BA7F955B3}"/>
              </a:ext>
            </a:extLst>
          </p:cNvPr>
          <p:cNvSpPr/>
          <p:nvPr/>
        </p:nvSpPr>
        <p:spPr>
          <a:xfrm>
            <a:off x="3388682" y="3486443"/>
            <a:ext cx="1233929" cy="2303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32507288-3160-4F9B-9E8B-C716121219ED}"/>
              </a:ext>
            </a:extLst>
          </p:cNvPr>
          <p:cNvSpPr/>
          <p:nvPr/>
        </p:nvSpPr>
        <p:spPr>
          <a:xfrm>
            <a:off x="5629037" y="3411005"/>
            <a:ext cx="1425340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2F2E75C-FCE0-4B99-8057-E2A823C26F64}"/>
              </a:ext>
            </a:extLst>
          </p:cNvPr>
          <p:cNvSpPr txBox="1"/>
          <p:nvPr/>
        </p:nvSpPr>
        <p:spPr>
          <a:xfrm>
            <a:off x="1331168" y="2003806"/>
            <a:ext cx="1677810" cy="120789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endParaRPr lang="en-US" altLang="ja-JP" sz="1049" dirty="0"/>
          </a:p>
          <a:p>
            <a:r>
              <a:rPr lang="en-US" altLang="ja-JP" sz="1000" dirty="0"/>
              <a:t>       Upgrading</a:t>
            </a:r>
          </a:p>
          <a:p>
            <a:r>
              <a:rPr lang="en-US" altLang="ja-JP" sz="1000" dirty="0"/>
              <a:t>     </a:t>
            </a:r>
            <a:r>
              <a:rPr lang="ja-JP" altLang="en-US" sz="1000" dirty="0"/>
              <a:t>  </a:t>
            </a:r>
            <a:r>
              <a:rPr lang="en-US" altLang="ja-JP" sz="1000" dirty="0"/>
              <a:t>(N=96)</a:t>
            </a:r>
          </a:p>
          <a:p>
            <a:endParaRPr lang="en-US" altLang="ja-JP" sz="1000" dirty="0"/>
          </a:p>
          <a:p>
            <a:r>
              <a:rPr lang="en-US" altLang="ja-JP" sz="1000" dirty="0"/>
              <a:t>       No upgrading</a:t>
            </a:r>
          </a:p>
          <a:p>
            <a:r>
              <a:rPr lang="en-US" altLang="ja-JP" sz="1000" dirty="0"/>
              <a:t>       (N=263)</a:t>
            </a:r>
          </a:p>
          <a:p>
            <a:endParaRPr lang="ja-JP" altLang="en-US" sz="12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036393C-6480-4EDC-8873-48EE7DB9AB4A}"/>
              </a:ext>
            </a:extLst>
          </p:cNvPr>
          <p:cNvSpPr txBox="1"/>
          <p:nvPr/>
        </p:nvSpPr>
        <p:spPr>
          <a:xfrm rot="16200000">
            <a:off x="3630442" y="1961464"/>
            <a:ext cx="167069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BCR-free survival</a:t>
            </a:r>
            <a:endParaRPr lang="ja-JP" altLang="en-US" sz="1200" dirty="0"/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A9293E26-1E3D-404F-BA6F-DF1031BF8DBA}"/>
              </a:ext>
            </a:extLst>
          </p:cNvPr>
          <p:cNvCxnSpPr/>
          <p:nvPr/>
        </p:nvCxnSpPr>
        <p:spPr>
          <a:xfrm>
            <a:off x="1414064" y="2298631"/>
            <a:ext cx="206314" cy="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9A34F510-5E90-472E-9D25-5F10B069C120}"/>
              </a:ext>
            </a:extLst>
          </p:cNvPr>
          <p:cNvCxnSpPr/>
          <p:nvPr/>
        </p:nvCxnSpPr>
        <p:spPr>
          <a:xfrm>
            <a:off x="1414064" y="2729408"/>
            <a:ext cx="20631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C61B70B7-6764-4A39-8598-4484EE9E4934}"/>
              </a:ext>
            </a:extLst>
          </p:cNvPr>
          <p:cNvSpPr/>
          <p:nvPr/>
        </p:nvSpPr>
        <p:spPr>
          <a:xfrm>
            <a:off x="1321101" y="2156066"/>
            <a:ext cx="1233929" cy="8032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04FAB71-408D-41D1-8A25-9A774DE27F44}"/>
              </a:ext>
            </a:extLst>
          </p:cNvPr>
          <p:cNvSpPr txBox="1"/>
          <p:nvPr/>
        </p:nvSpPr>
        <p:spPr>
          <a:xfrm>
            <a:off x="5004738" y="2001122"/>
            <a:ext cx="1677810" cy="120789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endParaRPr lang="en-US" altLang="ja-JP" sz="1049" dirty="0"/>
          </a:p>
          <a:p>
            <a:r>
              <a:rPr lang="en-US" altLang="ja-JP" sz="1000" dirty="0"/>
              <a:t>       Upgrading</a:t>
            </a:r>
          </a:p>
          <a:p>
            <a:r>
              <a:rPr lang="en-US" altLang="ja-JP" sz="1000" dirty="0"/>
              <a:t>     </a:t>
            </a:r>
            <a:r>
              <a:rPr lang="ja-JP" altLang="en-US" sz="1000" dirty="0"/>
              <a:t>  </a:t>
            </a:r>
            <a:r>
              <a:rPr lang="en-US" altLang="ja-JP" sz="1000" dirty="0"/>
              <a:t>(N=79)</a:t>
            </a:r>
          </a:p>
          <a:p>
            <a:endParaRPr lang="en-US" altLang="ja-JP" sz="1000" dirty="0"/>
          </a:p>
          <a:p>
            <a:r>
              <a:rPr lang="en-US" altLang="ja-JP" sz="1000" dirty="0"/>
              <a:t>       No upgrading</a:t>
            </a:r>
          </a:p>
          <a:p>
            <a:r>
              <a:rPr lang="en-US" altLang="ja-JP" sz="1000" dirty="0"/>
              <a:t>       (N=39)</a:t>
            </a:r>
          </a:p>
          <a:p>
            <a:endParaRPr lang="ja-JP" altLang="en-US" sz="1200" dirty="0"/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3E160932-AF78-42B0-8FA9-B407D2C22832}"/>
              </a:ext>
            </a:extLst>
          </p:cNvPr>
          <p:cNvCxnSpPr/>
          <p:nvPr/>
        </p:nvCxnSpPr>
        <p:spPr>
          <a:xfrm>
            <a:off x="5084313" y="2294822"/>
            <a:ext cx="206314" cy="0"/>
          </a:xfrm>
          <a:prstGeom prst="line">
            <a:avLst/>
          </a:prstGeom>
          <a:ln w="1905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CB34BBD1-E7F3-4B7B-BC73-9C53A527F686}"/>
              </a:ext>
            </a:extLst>
          </p:cNvPr>
          <p:cNvCxnSpPr/>
          <p:nvPr/>
        </p:nvCxnSpPr>
        <p:spPr>
          <a:xfrm>
            <a:off x="5084313" y="2725599"/>
            <a:ext cx="20631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15490940-8E99-4085-8637-93A6A339BE7D}"/>
              </a:ext>
            </a:extLst>
          </p:cNvPr>
          <p:cNvSpPr/>
          <p:nvPr/>
        </p:nvSpPr>
        <p:spPr>
          <a:xfrm>
            <a:off x="4991348" y="2152257"/>
            <a:ext cx="1233929" cy="8032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8EF12B93-AB81-4AF3-9D2B-07024FFF31C0}"/>
              </a:ext>
            </a:extLst>
          </p:cNvPr>
          <p:cNvSpPr/>
          <p:nvPr/>
        </p:nvSpPr>
        <p:spPr>
          <a:xfrm>
            <a:off x="1963342" y="3398168"/>
            <a:ext cx="1425340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D79426B-79BE-476D-9802-AAB82B2C5150}"/>
              </a:ext>
            </a:extLst>
          </p:cNvPr>
          <p:cNvSpPr txBox="1"/>
          <p:nvPr/>
        </p:nvSpPr>
        <p:spPr>
          <a:xfrm>
            <a:off x="1897213" y="3426649"/>
            <a:ext cx="1682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Follow-up (months)</a:t>
            </a:r>
            <a:endParaRPr lang="ja-JP" altLang="en-US" sz="12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988D98A-1273-40BD-9766-A4ABAE084DD6}"/>
              </a:ext>
            </a:extLst>
          </p:cNvPr>
          <p:cNvSpPr txBox="1"/>
          <p:nvPr/>
        </p:nvSpPr>
        <p:spPr>
          <a:xfrm>
            <a:off x="5571663" y="3425713"/>
            <a:ext cx="1682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Follow-up (months)</a:t>
            </a:r>
            <a:endParaRPr lang="ja-JP" altLang="en-US" sz="1200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62F960A-4F83-4295-A564-A989B9011BEF}"/>
              </a:ext>
            </a:extLst>
          </p:cNvPr>
          <p:cNvSpPr txBox="1"/>
          <p:nvPr/>
        </p:nvSpPr>
        <p:spPr>
          <a:xfrm rot="16200000">
            <a:off x="-215959" y="1841454"/>
            <a:ext cx="191071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BCR-free survival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662222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97</Words>
  <Application>Microsoft Office PowerPoint</Application>
  <PresentationFormat>ワイド画面</PresentationFormat>
  <Paragraphs>2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shima Yuta</dc:creator>
  <cp:lastModifiedBy>雄太 山田</cp:lastModifiedBy>
  <cp:revision>5</cp:revision>
  <dcterms:created xsi:type="dcterms:W3CDTF">2021-04-05T03:48:08Z</dcterms:created>
  <dcterms:modified xsi:type="dcterms:W3CDTF">2021-04-12T05:15:13Z</dcterms:modified>
</cp:coreProperties>
</file>